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074" r:id="rId2"/>
  </p:sldIdLst>
  <p:sldSz cx="7562850" cy="10688638"/>
  <p:notesSz cx="6886575" cy="100171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11" userDrawn="1">
          <p15:clr>
            <a:srgbClr val="A4A3A4"/>
          </p15:clr>
        </p15:guide>
        <p15:guide id="2" pos="243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min Kwon" initials="JK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FF5050"/>
    <a:srgbClr val="F880EF"/>
    <a:srgbClr val="00B4B8"/>
    <a:srgbClr val="B313A0"/>
    <a:srgbClr val="229662"/>
    <a:srgbClr val="9999FF"/>
    <a:srgbClr val="66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38" autoAdjust="0"/>
    <p:restoredTop sz="94660"/>
  </p:normalViewPr>
  <p:slideViewPr>
    <p:cSldViewPr snapToGrid="0">
      <p:cViewPr varScale="1">
        <p:scale>
          <a:sx n="47" d="100"/>
          <a:sy n="47" d="100"/>
        </p:scale>
        <p:origin x="1526" y="53"/>
      </p:cViewPr>
      <p:guideLst>
        <p:guide orient="horz" pos="2911"/>
        <p:guide pos="243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-115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183" cy="502596"/>
          </a:xfrm>
          <a:prstGeom prst="rect">
            <a:avLst/>
          </a:prstGeom>
        </p:spPr>
        <p:txBody>
          <a:bodyPr vert="horz" lIns="96588" tIns="48294" rIns="96588" bIns="4829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0799" y="0"/>
            <a:ext cx="2984183" cy="502596"/>
          </a:xfrm>
          <a:prstGeom prst="rect">
            <a:avLst/>
          </a:prstGeom>
        </p:spPr>
        <p:txBody>
          <a:bodyPr vert="horz" lIns="96588" tIns="48294" rIns="96588" bIns="48294" rtlCol="0"/>
          <a:lstStyle>
            <a:lvl1pPr algn="r">
              <a:defRPr sz="1300"/>
            </a:lvl1pPr>
          </a:lstStyle>
          <a:p>
            <a:fld id="{95BA9F53-583B-4BC8-9B65-57AB0FCA508E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7900" y="1252538"/>
            <a:ext cx="2390775" cy="33797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588" tIns="48294" rIns="96588" bIns="4829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658" y="4820741"/>
            <a:ext cx="5509260" cy="3944243"/>
          </a:xfrm>
          <a:prstGeom prst="rect">
            <a:avLst/>
          </a:prstGeom>
        </p:spPr>
        <p:txBody>
          <a:bodyPr vert="horz" lIns="96588" tIns="48294" rIns="96588" bIns="4829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4531"/>
            <a:ext cx="2984183" cy="502595"/>
          </a:xfrm>
          <a:prstGeom prst="rect">
            <a:avLst/>
          </a:prstGeom>
        </p:spPr>
        <p:txBody>
          <a:bodyPr vert="horz" lIns="96588" tIns="48294" rIns="96588" bIns="4829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0799" y="9514531"/>
            <a:ext cx="2984183" cy="502595"/>
          </a:xfrm>
          <a:prstGeom prst="rect">
            <a:avLst/>
          </a:prstGeom>
        </p:spPr>
        <p:txBody>
          <a:bodyPr vert="horz" lIns="96588" tIns="48294" rIns="96588" bIns="48294" rtlCol="0" anchor="b"/>
          <a:lstStyle>
            <a:lvl1pPr algn="r">
              <a:defRPr sz="1300"/>
            </a:lvl1pPr>
          </a:lstStyle>
          <a:p>
            <a:fld id="{97DA4AF1-7D0D-4EB7-BB4A-34C373463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46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1749275"/>
            <a:ext cx="6428423" cy="3721230"/>
          </a:xfrm>
        </p:spPr>
        <p:txBody>
          <a:bodyPr anchor="b"/>
          <a:lstStyle>
            <a:lvl1pPr algn="ctr">
              <a:defRPr sz="496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356" y="5614010"/>
            <a:ext cx="5672138" cy="2580613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150" indent="0" algn="ctr">
              <a:buNone/>
              <a:defRPr sz="1654"/>
            </a:lvl2pPr>
            <a:lvl3pPr marL="756300" indent="0" algn="ctr">
              <a:buNone/>
              <a:defRPr sz="1489"/>
            </a:lvl3pPr>
            <a:lvl4pPr marL="1134450" indent="0" algn="ctr">
              <a:buNone/>
              <a:defRPr sz="1323"/>
            </a:lvl4pPr>
            <a:lvl5pPr marL="1512600" indent="0" algn="ctr">
              <a:buNone/>
              <a:defRPr sz="1323"/>
            </a:lvl5pPr>
            <a:lvl6pPr marL="1890751" indent="0" algn="ctr">
              <a:buNone/>
              <a:defRPr sz="1323"/>
            </a:lvl6pPr>
            <a:lvl7pPr marL="2268901" indent="0" algn="ctr">
              <a:buNone/>
              <a:defRPr sz="1323"/>
            </a:lvl7pPr>
            <a:lvl8pPr marL="2647051" indent="0" algn="ctr">
              <a:buNone/>
              <a:defRPr sz="1323"/>
            </a:lvl8pPr>
            <a:lvl9pPr marL="3025201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71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954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2165" y="569071"/>
            <a:ext cx="1630740" cy="905812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946" y="569071"/>
            <a:ext cx="4797683" cy="905812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751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672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007" y="2664740"/>
            <a:ext cx="6522958" cy="4446176"/>
          </a:xfrm>
        </p:spPr>
        <p:txBody>
          <a:bodyPr anchor="b"/>
          <a:lstStyle>
            <a:lvl1pPr>
              <a:defRPr sz="496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007" y="7152978"/>
            <a:ext cx="6522958" cy="2338139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15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300" indent="0">
              <a:buNone/>
              <a:defRPr sz="1489">
                <a:solidFill>
                  <a:schemeClr val="tx1">
                    <a:tint val="75000"/>
                  </a:schemeClr>
                </a:solidFill>
              </a:defRPr>
            </a:lvl3pPr>
            <a:lvl4pPr marL="113445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60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7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9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70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52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784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946" y="2845355"/>
            <a:ext cx="3214211" cy="678184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8693" y="2845355"/>
            <a:ext cx="3214211" cy="678184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574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569073"/>
            <a:ext cx="6522958" cy="20659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932" y="2620202"/>
            <a:ext cx="3199440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932" y="3904322"/>
            <a:ext cx="3199440" cy="5742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8693" y="2620202"/>
            <a:ext cx="3215196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8693" y="3904322"/>
            <a:ext cx="3215196" cy="57426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1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24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29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5196" y="1538968"/>
            <a:ext cx="3828693" cy="7595861"/>
          </a:xfrm>
        </p:spPr>
        <p:txBody>
          <a:bodyPr/>
          <a:lstStyle>
            <a:lvl1pPr>
              <a:defRPr sz="2647"/>
            </a:lvl1pPr>
            <a:lvl2pPr>
              <a:defRPr sz="2316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20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5196" y="1538968"/>
            <a:ext cx="3828693" cy="7595861"/>
          </a:xfrm>
        </p:spPr>
        <p:txBody>
          <a:bodyPr anchor="t"/>
          <a:lstStyle>
            <a:lvl1pPr marL="0" indent="0">
              <a:buNone/>
              <a:defRPr sz="2647"/>
            </a:lvl1pPr>
            <a:lvl2pPr marL="378150" indent="0">
              <a:buNone/>
              <a:defRPr sz="2316"/>
            </a:lvl2pPr>
            <a:lvl3pPr marL="756300" indent="0">
              <a:buNone/>
              <a:defRPr sz="1985"/>
            </a:lvl3pPr>
            <a:lvl4pPr marL="1134450" indent="0">
              <a:buNone/>
              <a:defRPr sz="1654"/>
            </a:lvl4pPr>
            <a:lvl5pPr marL="1512600" indent="0">
              <a:buNone/>
              <a:defRPr sz="1654"/>
            </a:lvl5pPr>
            <a:lvl6pPr marL="1890751" indent="0">
              <a:buNone/>
              <a:defRPr sz="1654"/>
            </a:lvl6pPr>
            <a:lvl7pPr marL="2268901" indent="0">
              <a:buNone/>
              <a:defRPr sz="1654"/>
            </a:lvl7pPr>
            <a:lvl8pPr marL="2647051" indent="0">
              <a:buNone/>
              <a:defRPr sz="1654"/>
            </a:lvl8pPr>
            <a:lvl9pPr marL="3025201" indent="0">
              <a:buNone/>
              <a:defRPr sz="1654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202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946" y="569073"/>
            <a:ext cx="6522958" cy="20659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946" y="2845355"/>
            <a:ext cx="6522958" cy="67818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946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0DAA8-B887-4CF5-8706-9191B375691A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5194" y="9906786"/>
            <a:ext cx="2552462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1263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95E87-4FE9-4CD2-B0CE-623BCE2A8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447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56300" rtl="0" eaLnBrk="1" latinLnBrk="0" hangingPunct="1">
        <a:lnSpc>
          <a:spcPct val="90000"/>
        </a:lnSpc>
        <a:spcBef>
          <a:spcPct val="0"/>
        </a:spcBef>
        <a:buNone/>
        <a:defRPr sz="36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75" indent="-189075" algn="l" defTabSz="75630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6" kern="1200">
          <a:solidFill>
            <a:schemeClr val="tx1"/>
          </a:solidFill>
          <a:latin typeface="+mn-lt"/>
          <a:ea typeface="+mn-ea"/>
          <a:cs typeface="+mn-cs"/>
        </a:defRPr>
      </a:lvl1pPr>
      <a:lvl2pPr marL="5672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37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5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7016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20798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4579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8361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2142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1pPr>
      <a:lvl2pPr marL="3781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2pPr>
      <a:lvl3pPr marL="7563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3pPr>
      <a:lvl4pPr marL="11344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5126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18907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2689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6470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0252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CDD8338-6AE6-455E-8EF3-EA0479E93199}"/>
              </a:ext>
            </a:extLst>
          </p:cNvPr>
          <p:cNvSpPr txBox="1"/>
          <p:nvPr/>
        </p:nvSpPr>
        <p:spPr>
          <a:xfrm>
            <a:off x="382269" y="4037013"/>
            <a:ext cx="64630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800"/>
              </a:spcAft>
            </a:pPr>
            <a:r>
              <a:rPr lang="en-GB" sz="11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1 Figure. Specialty of total survey subjects. </a:t>
            </a:r>
            <a:r>
              <a:rPr lang="en-GB" sz="1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stribution of each speciality is indicated by n (%)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AFA1B5D-8937-4555-B27A-A310B05D21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0473" y="513747"/>
            <a:ext cx="5250180" cy="3133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4724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82</TotalTime>
  <Words>18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in Kwon</dc:creator>
  <cp:lastModifiedBy>Nishi Masahiro</cp:lastModifiedBy>
  <cp:revision>574</cp:revision>
  <cp:lastPrinted>2021-03-21T12:21:40Z</cp:lastPrinted>
  <dcterms:created xsi:type="dcterms:W3CDTF">2020-03-20T20:12:45Z</dcterms:created>
  <dcterms:modified xsi:type="dcterms:W3CDTF">2021-07-08T13:53:00Z</dcterms:modified>
</cp:coreProperties>
</file>